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78DA35-17A3-418C-9440-9592812D66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C3AF873-3B55-41FA-AC8C-18B0861D65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F7B90C-F3AC-4921-A278-9F4C777A5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0F339C-58AB-4DC1-83BF-2D6505761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4A033D-FB1A-42CC-BC46-95D499830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5067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3F3E54-51AC-4F72-847C-D4417AA6A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F4F14AC-4490-4DFC-B35A-FD206DFD16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BC0E83-E0B4-41FB-970E-349FB2089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C72858-DBBF-40A0-9A6E-74CCD2983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BC877B-7875-47F0-930E-3622A6D56A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1390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97EB033-21FF-48F5-9BC7-F713A87A06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B275E43-5FF0-4D15-8356-30889B3D87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60F0DF-80FD-4B2C-BEBA-40884C03C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548900-68F0-4424-BB86-ECDB4964A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19C86C-712F-48BA-A2FF-7156D2DB1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5642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FF978C-E62A-4E73-A393-56F66C4633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1DF5DF2-7329-4B3E-9EA9-1C88356005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4A78C56-031F-4198-98A9-260848E48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75EB69-CC99-4265-924A-40502238D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6E77AA4-C58E-4E51-A1E2-9391CDB43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554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DF64E1-AA15-4BFB-96F3-CF61C7CC0A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8D09484-D80C-4478-A772-8A81ABE78D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4FA8FF0-ADA3-40EB-AE33-E8074E543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A119F4-42E6-46C4-AC23-05C719684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EE8ACA-89BF-430E-A3AC-49F510571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0601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BC064C-D400-42C8-B2AF-2AA97270F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460BCB2-3ADA-4008-9056-D1A73E5B94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376A4C3-0657-4A06-AD9A-0047093EE4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C8A7241-282C-46D9-94DE-140C9916B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2AA5AB0-F97B-469A-BA47-BA67FB8FB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87D7DD-A725-4732-88D2-F62F3A7F6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5224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64E60F-7848-4853-88E7-AA0EE0D85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7D1907F-03EC-4CB0-9D79-CD2AD3592E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0838257-6A28-481F-901A-E1CC1ED2D4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E5942A-ACD6-4B0A-9149-D7724865E9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02BB2ED-6721-4283-B9AD-E940A88EA6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EA58FBE-1DA0-47D1-A625-7A5E238F0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388E45E-A691-40FA-B373-F0FBAEBEF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30431D1-18A0-4244-BA23-70B223281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7809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15EB8D-EBBB-4928-A6CB-505970EE7B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CB5DE64-EC48-47D5-9C4B-DC81D3B2E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5EB98A3-9700-4A7B-9915-87F42DDEC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6E0CCA4-6AAD-4649-B96B-D97252495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4152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FCAF46B-92A9-4957-BEDA-C7EB58D7C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4F155E7-DA46-4270-9913-E39FFB230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9AABC4D-8644-4080-9DAF-D5A977C70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9357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BC2C7E-7A8E-4272-8CC2-9DCBB336CB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AA2BD3-F750-40DF-AA28-A02D39D78B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0CD5C3D-6C85-46F5-A66D-2FACDC8F23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4EFFF6-83B6-419F-B80E-EFC02096B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CA1D64D-4810-4079-B82A-EBAED1A03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D46412B-8613-4941-B504-E57E19A09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6317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B85F89-4C4F-4F2D-87D1-E4C52E369F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1AC8578-A315-4B4A-9A1F-5B35FF472E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D7CB291-9E87-491D-A6C8-1A9222F6D8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39799E8-D323-4D18-B6DE-305303898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7471013-111D-4EF3-A001-6FEFA7DDE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FF5B3B-2026-4C7D-8DA0-66B5CDEED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981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BAE2116-BC72-40E2-9B55-66E57ECCB1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C3C825-8870-4847-AD6D-432E860238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F173FCE-3709-44AD-B0CC-A4740C8653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E65BC3-2BE8-4FFC-B910-11A207B1480D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901D2B-EA2D-4940-8DE0-B37F4BB837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F905F4-C668-4D00-9FFF-17C9CFF1C8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31318D-A0D5-4165-B049-D7BE57B5A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405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4AEF947-A371-406D-804B-1284D44A1F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3469" y="767420"/>
            <a:ext cx="4918577" cy="576210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17A24EC4-AEDD-4478-9569-393F7102DC2B}"/>
              </a:ext>
            </a:extLst>
          </p:cNvPr>
          <p:cNvSpPr txBox="1"/>
          <p:nvPr/>
        </p:nvSpPr>
        <p:spPr>
          <a:xfrm>
            <a:off x="674704" y="490421"/>
            <a:ext cx="691570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. S6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 Clinical traits comparison among different groups in NASH mice</a:t>
            </a:r>
            <a:endParaRPr lang="zh-CN" altLang="en-US" sz="12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5E2231B-0EB7-4E2A-8780-CABDA971C516}"/>
              </a:ext>
            </a:extLst>
          </p:cNvPr>
          <p:cNvSpPr txBox="1"/>
          <p:nvPr/>
        </p:nvSpPr>
        <p:spPr>
          <a:xfrm>
            <a:off x="507507" y="6396335"/>
            <a:ext cx="1117698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1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ntervention groups: EHFD, exercise plus high fat diet; ELFD, exercise plus low fat diet; HFD, high fat diet; LFD, low fat diet; MCSM, methionine choline sufficient diet (4 weeks). None intervention groups: MCD, methionine choline deficiency diet (8 weeks); MCSC, methionine choline sufficient diet (8 weeks).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374340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8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ana</dc:creator>
  <cp:lastModifiedBy>Wu Na</cp:lastModifiedBy>
  <cp:revision>6</cp:revision>
  <dcterms:created xsi:type="dcterms:W3CDTF">2021-04-26T05:12:28Z</dcterms:created>
  <dcterms:modified xsi:type="dcterms:W3CDTF">2021-08-16T11:31:51Z</dcterms:modified>
</cp:coreProperties>
</file>